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9"/>
  </p:notesMasterIdLst>
  <p:sldIdLst>
    <p:sldId id="284" r:id="rId2"/>
    <p:sldId id="277" r:id="rId3"/>
    <p:sldId id="285" r:id="rId4"/>
    <p:sldId id="282" r:id="rId5"/>
    <p:sldId id="283" r:id="rId6"/>
    <p:sldId id="262" r:id="rId7"/>
    <p:sldId id="268" r:id="rId8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49" userDrawn="1">
          <p15:clr>
            <a:srgbClr val="A4A3A4"/>
          </p15:clr>
        </p15:guide>
        <p15:guide id="2" pos="386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216"/>
    <p:restoredTop sz="96940" autoAdjust="0"/>
  </p:normalViewPr>
  <p:slideViewPr>
    <p:cSldViewPr snapToGrid="0" snapToObjects="1" showGuides="1">
      <p:cViewPr varScale="1">
        <p:scale>
          <a:sx n="119" d="100"/>
          <a:sy n="119" d="100"/>
        </p:scale>
        <p:origin x="392" y="176"/>
      </p:cViewPr>
      <p:guideLst>
        <p:guide orient="horz" pos="1049"/>
        <p:guide pos="386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4753ADB-624B-974A-B83E-6157ED204766}" type="datetimeFigureOut">
              <a:rPr kumimoji="1" lang="ja-JP" altLang="en-US" smtClean="0"/>
              <a:t>2021/12/3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B470BA-6A0B-AF4A-A025-548692C2AC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01654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7B470BA-6A0B-AF4A-A025-548692C2AC6F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334799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7B470BA-6A0B-AF4A-A025-548692C2AC6F}" type="slidenum">
              <a:rPr kumimoji="1" lang="ja-JP" altLang="en-US" smtClean="0"/>
              <a:t>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974785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7B470BA-6A0B-AF4A-A025-548692C2AC6F}" type="slidenum">
              <a:rPr kumimoji="1" lang="ja-JP" altLang="en-US" smtClean="0"/>
              <a:t>7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733128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43780EC-F5E3-7F4B-94AE-8E1E787282B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31112BEA-D6B4-D34B-925C-86D34E2E3F9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4D03988-3A4E-F34F-8D82-8FEE18D074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7F76A-9196-C44B-9F58-711F2C6ED4B6}" type="datetimeFigureOut">
              <a:rPr kumimoji="1" lang="ja-JP" altLang="en-US" smtClean="0"/>
              <a:t>2021/12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623AB7F-0128-7049-ABB2-3A77AB9146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34C75A3-119C-724F-975F-899D7D9B9B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8DEE15-A5EF-D64C-8426-8CCBDB6617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73703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21E8318-2010-C740-A103-9DE1A012A2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F04808D-3D26-0447-92E0-53E929781B2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53F5A35-F6D4-3145-84C1-E0805998A7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7F76A-9196-C44B-9F58-711F2C6ED4B6}" type="datetimeFigureOut">
              <a:rPr kumimoji="1" lang="ja-JP" altLang="en-US" smtClean="0"/>
              <a:t>2021/12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1344A51-0F44-3A4E-A3F2-DC7032B02B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DD25432-7C17-B748-AC71-A5B01A37B3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8DEE15-A5EF-D64C-8426-8CCBDB6617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81329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DDB3D335-2389-2E4A-ACCF-52136F65A48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E78E068-0EE9-8D46-9BBA-D63D4345987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1D182E3-3434-004C-B2F2-88EA1C2832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7F76A-9196-C44B-9F58-711F2C6ED4B6}" type="datetimeFigureOut">
              <a:rPr kumimoji="1" lang="ja-JP" altLang="en-US" smtClean="0"/>
              <a:t>2021/12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DEE904D-F6C0-F04E-B891-F0FDF1EAC9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21DEE29-C8FA-784D-B3D3-DD7D5AD8F7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8DEE15-A5EF-D64C-8426-8CCBDB6617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95484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8C0FE88-2326-5F4E-9D8C-5599CDEA12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342E3F2-F092-1B4B-930D-343278FA386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33AE5DE-24D3-C040-9DE4-A207804F9A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7F76A-9196-C44B-9F58-711F2C6ED4B6}" type="datetimeFigureOut">
              <a:rPr kumimoji="1" lang="ja-JP" altLang="en-US" smtClean="0"/>
              <a:t>2021/12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58D73BD-70F1-1248-9D40-04D61EA39F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3DFA35E-6B65-044E-A550-63893218D6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8DEE15-A5EF-D64C-8426-8CCBDB6617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45879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E8E3D12-A072-2147-ACCC-94BB5915CE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2CA4459-99F0-7741-84DE-A1616F2FA6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82E16F7-B4D5-0347-AD89-AA7B3FE91F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7F76A-9196-C44B-9F58-711F2C6ED4B6}" type="datetimeFigureOut">
              <a:rPr kumimoji="1" lang="ja-JP" altLang="en-US" smtClean="0"/>
              <a:t>2021/12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EBBBF02-8E18-664C-9E10-3558D76495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5BA95FC-00FC-4541-AF2D-B1CE590EA8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8DEE15-A5EF-D64C-8426-8CCBDB6617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34373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92C7BD9-9249-9549-994F-6148A35E64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155EF9C-9CD1-FC49-8DEF-C7F9FBE97EE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786CB7C-63AD-B849-B9FE-3CE779A34B6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88B8162-436D-B447-9CC6-EA4A8C92E7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7F76A-9196-C44B-9F58-711F2C6ED4B6}" type="datetimeFigureOut">
              <a:rPr kumimoji="1" lang="ja-JP" altLang="en-US" smtClean="0"/>
              <a:t>2021/12/3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4C9AC41-8CFE-FC40-A11E-BD7FFEA910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25578B7-344C-494E-84E8-5FE707BBA3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8DEE15-A5EF-D64C-8426-8CCBDB6617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18032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CE5B95B-FD96-1442-A29E-80AFBE8A92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6AFD886-EBB2-034B-8DE1-FD3530FB4C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F6D9E3A-A3B2-9D4B-940B-A3081640E5E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1F7948AE-88B8-FA4B-BFFF-84E892AF2B1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1C3A0F63-2BF3-7F4B-A2B3-779B22DF42D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F5C704B5-C6A0-D54E-8EFD-7109BA4070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7F76A-9196-C44B-9F58-711F2C6ED4B6}" type="datetimeFigureOut">
              <a:rPr kumimoji="1" lang="ja-JP" altLang="en-US" smtClean="0"/>
              <a:t>2021/12/3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5C39FAD9-9865-364E-ABD2-CA23F55D06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1A05DB00-CFDA-CC4C-868E-C7D9194876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8DEE15-A5EF-D64C-8426-8CCBDB6617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20681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DE3CD7C-4DAC-C94F-B758-5A14EBC2EA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8F8E3F5-F41C-AF45-854A-CE15D14241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7F76A-9196-C44B-9F58-711F2C6ED4B6}" type="datetimeFigureOut">
              <a:rPr kumimoji="1" lang="ja-JP" altLang="en-US" smtClean="0"/>
              <a:t>2021/12/3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7ABAF82-E775-F441-964D-883371A4C7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DB220274-0C4C-6A4E-8932-2D4A471C51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8DEE15-A5EF-D64C-8426-8CCBDB6617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21194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9B7138BB-53C3-6743-8F8F-AB163FDC11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7F76A-9196-C44B-9F58-711F2C6ED4B6}" type="datetimeFigureOut">
              <a:rPr kumimoji="1" lang="ja-JP" altLang="en-US" smtClean="0"/>
              <a:t>2021/12/3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D4F990F0-497D-7145-90E9-FB708761F2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4840CE16-B631-2948-B992-9B246DA5AC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8DEE15-A5EF-D64C-8426-8CCBDB6617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5644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7D1D910-3473-C147-AFF8-ED83EFD654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FD00F39-516D-0E42-A69F-1D626001B2F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2BF8D79-1125-EA4E-9990-017C5742DCA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54FD970-E808-4A4F-A949-846A1D040A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7F76A-9196-C44B-9F58-711F2C6ED4B6}" type="datetimeFigureOut">
              <a:rPr kumimoji="1" lang="ja-JP" altLang="en-US" smtClean="0"/>
              <a:t>2021/12/3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F27D547-B365-1147-BE43-8CB8CCC08D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AE5AF7F-3BD3-EB42-9577-5F1A5DC19A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8DEE15-A5EF-D64C-8426-8CCBDB6617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35501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CCD75AD-8F7B-344B-9E55-B4FC3BCEDD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F0EB31A1-16B1-BC44-BB3E-C66349D4EAC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E56AE1A-3C71-AE4D-A914-1B66480CAEA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EA3A743-C4C5-764C-A768-EEB076825A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7F76A-9196-C44B-9F58-711F2C6ED4B6}" type="datetimeFigureOut">
              <a:rPr kumimoji="1" lang="ja-JP" altLang="en-US" smtClean="0"/>
              <a:t>2021/12/3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E582560-07CF-5640-8827-1D077627B4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8B7C7F5-61A7-4C4A-8DA4-1169F31829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8DEE15-A5EF-D64C-8426-8CCBDB6617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90018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403AF192-31AB-DC47-BF2E-4D84813F4A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C1B2CBB-0134-6D46-B05A-AA8FE966D7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AA65DD2-BFB8-8442-80B1-64D6013EF53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17F76A-9196-C44B-9F58-711F2C6ED4B6}" type="datetimeFigureOut">
              <a:rPr kumimoji="1" lang="ja-JP" altLang="en-US" smtClean="0"/>
              <a:t>2021/12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8C6B446-C1C8-6847-A642-257C22DCA55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087C070-4C32-C849-8EEE-B93F6C057CA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8DEE15-A5EF-D64C-8426-8CCBDB6617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3955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23384A2E-3474-7146-BFDE-C7893548FBF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32512" y="1647802"/>
            <a:ext cx="4543725" cy="3934362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5669667E-BC4C-844D-87DE-51C6C602CCD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15562" y="2262301"/>
            <a:ext cx="4543725" cy="2781872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BCA81B4B-AA23-3743-AFA7-25C4AB66EA1A}"/>
              </a:ext>
            </a:extLst>
          </p:cNvPr>
          <p:cNvSpPr txBox="1"/>
          <p:nvPr/>
        </p:nvSpPr>
        <p:spPr>
          <a:xfrm>
            <a:off x="1337532" y="1295956"/>
            <a:ext cx="7606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(a)</a:t>
            </a:r>
            <a:endParaRPr kumimoji="1" lang="ja-JP" altLang="en-US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0F0F1892-1992-6A41-BE29-EE2FB1094781}"/>
              </a:ext>
            </a:extLst>
          </p:cNvPr>
          <p:cNvSpPr txBox="1"/>
          <p:nvPr/>
        </p:nvSpPr>
        <p:spPr>
          <a:xfrm>
            <a:off x="6132513" y="1295956"/>
            <a:ext cx="7504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(b)</a:t>
            </a:r>
            <a:endParaRPr kumimoji="1" lang="ja-JP" altLang="en-US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cxnSp>
        <p:nvCxnSpPr>
          <p:cNvPr id="4" name="直線コネクタ 3">
            <a:extLst>
              <a:ext uri="{FF2B5EF4-FFF2-40B4-BE49-F238E27FC236}">
                <a16:creationId xmlns:a16="http://schemas.microsoft.com/office/drawing/2014/main" id="{5F992E6A-5244-174A-BD82-0FDE87506703}"/>
              </a:ext>
            </a:extLst>
          </p:cNvPr>
          <p:cNvCxnSpPr>
            <a:cxnSpLocks/>
          </p:cNvCxnSpPr>
          <p:nvPr/>
        </p:nvCxnSpPr>
        <p:spPr>
          <a:xfrm>
            <a:off x="9304295" y="1828800"/>
            <a:ext cx="0" cy="3188043"/>
          </a:xfrm>
          <a:prstGeom prst="line">
            <a:avLst/>
          </a:prstGeom>
          <a:ln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F1D886C9-ADA5-B84B-939F-9E20B34CB724}"/>
              </a:ext>
            </a:extLst>
          </p:cNvPr>
          <p:cNvSpPr/>
          <p:nvPr/>
        </p:nvSpPr>
        <p:spPr>
          <a:xfrm>
            <a:off x="77255" y="6488668"/>
            <a:ext cx="354616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Supplementary Figure S1</a:t>
            </a:r>
            <a:r>
              <a:rPr lang="ja-JP" altLang="ja-JP" b="1">
                <a:latin typeface="Verdana" panose="020B0604030504040204" pitchFamily="34" charset="0"/>
                <a:cs typeface="Verdana" panose="020B0604030504040204" pitchFamily="34" charset="0"/>
              </a:rPr>
              <a:t> </a:t>
            </a:r>
            <a:endParaRPr lang="ja-JP" altLang="en-US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753047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840918FC-C987-4048-A7B1-892B0EAD627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14005"/>
          <a:stretch/>
        </p:blipFill>
        <p:spPr>
          <a:xfrm>
            <a:off x="839309" y="680482"/>
            <a:ext cx="6611819" cy="5313621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058C69F2-C474-CE4E-8578-1318EB64827D}"/>
              </a:ext>
            </a:extLst>
          </p:cNvPr>
          <p:cNvSpPr txBox="1"/>
          <p:nvPr/>
        </p:nvSpPr>
        <p:spPr>
          <a:xfrm>
            <a:off x="7760032" y="2957681"/>
            <a:ext cx="443196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Hatched line; genus </a:t>
            </a:r>
            <a:r>
              <a:rPr kumimoji="1" lang="en-US" altLang="ja-JP" sz="1200" b="1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Ruminococcus</a:t>
            </a:r>
            <a:r>
              <a:rPr kumimoji="1" lang="en-US" altLang="ja-JP" sz="12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</a:t>
            </a:r>
          </a:p>
          <a:p>
            <a:r>
              <a:rPr lang="en-US" altLang="ja-JP" sz="12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                          </a:t>
            </a:r>
            <a:r>
              <a:rPr kumimoji="1" lang="en-US" altLang="ja-JP" sz="12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(family </a:t>
            </a:r>
            <a:r>
              <a:rPr kumimoji="1" lang="en-US" altLang="ja-JP" sz="1200" b="1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Ruminococcaceae</a:t>
            </a:r>
            <a:r>
              <a:rPr kumimoji="1" lang="en-US" altLang="ja-JP" sz="12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),</a:t>
            </a:r>
          </a:p>
          <a:p>
            <a:r>
              <a:rPr kumimoji="1" lang="en-US" altLang="ja-JP" sz="12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Horizontal line; </a:t>
            </a:r>
            <a:r>
              <a:rPr kumimoji="1" lang="en-US" altLang="ja-JP" sz="1200" b="1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Unclassifed</a:t>
            </a:r>
            <a:r>
              <a:rPr kumimoji="1" lang="en-US" altLang="ja-JP" sz="12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genus belonging to </a:t>
            </a:r>
          </a:p>
          <a:p>
            <a:r>
              <a:rPr lang="en-US" altLang="ja-JP" sz="12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                           </a:t>
            </a:r>
            <a:r>
              <a:rPr kumimoji="1" lang="en-US" altLang="ja-JP" sz="12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family </a:t>
            </a:r>
            <a:r>
              <a:rPr kumimoji="1" lang="en-US" altLang="ja-JP" sz="1200" b="1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Ruminococcaceae</a:t>
            </a:r>
            <a:endParaRPr lang="en-US" altLang="ja-JP" sz="1200" b="1" dirty="0"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  <a:p>
            <a:r>
              <a:rPr lang="en-US" altLang="ja-JP" sz="12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Filled; Family </a:t>
            </a:r>
            <a:r>
              <a:rPr lang="en-US" altLang="ja-JP" sz="1200" b="1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Ruminococcaceae</a:t>
            </a:r>
            <a:endParaRPr kumimoji="1" lang="ja-JP" altLang="en-US" sz="1200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7750C2BA-8F47-3545-A950-FF27A3B8C922}"/>
              </a:ext>
            </a:extLst>
          </p:cNvPr>
          <p:cNvSpPr/>
          <p:nvPr/>
        </p:nvSpPr>
        <p:spPr>
          <a:xfrm>
            <a:off x="77255" y="6488668"/>
            <a:ext cx="354616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Supplementary Figure S2</a:t>
            </a:r>
            <a:r>
              <a:rPr lang="ja-JP" altLang="ja-JP" b="1">
                <a:latin typeface="Verdana" panose="020B0604030504040204" pitchFamily="34" charset="0"/>
                <a:cs typeface="Verdana" panose="020B0604030504040204" pitchFamily="34" charset="0"/>
              </a:rPr>
              <a:t> </a:t>
            </a:r>
            <a:endParaRPr lang="ja-JP" altLang="en-US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136044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26B28505-C17E-C54F-B454-1B69A3D22F9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50004" y="125730"/>
            <a:ext cx="3950377" cy="6537960"/>
          </a:xfrm>
          <a:prstGeom prst="rect">
            <a:avLst/>
          </a:prstGeom>
        </p:spPr>
      </p:pic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D4770F23-85A8-5246-9A54-78F2A13E7801}"/>
              </a:ext>
            </a:extLst>
          </p:cNvPr>
          <p:cNvSpPr/>
          <p:nvPr/>
        </p:nvSpPr>
        <p:spPr>
          <a:xfrm>
            <a:off x="77255" y="6488668"/>
            <a:ext cx="354616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Supplementary Figure S3</a:t>
            </a:r>
            <a:r>
              <a:rPr lang="ja-JP" altLang="ja-JP" b="1">
                <a:latin typeface="Verdana" panose="020B0604030504040204" pitchFamily="34" charset="0"/>
                <a:cs typeface="Verdana" panose="020B0604030504040204" pitchFamily="34" charset="0"/>
              </a:rPr>
              <a:t> </a:t>
            </a:r>
            <a:endParaRPr lang="ja-JP" altLang="en-US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443644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B8E97D00-8F86-6D43-B258-5CC812AB4DC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81859" y="1398330"/>
            <a:ext cx="8089732" cy="4785475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BEB46D06-29AD-FD43-9C05-49049D01A936}"/>
              </a:ext>
            </a:extLst>
          </p:cNvPr>
          <p:cNvSpPr txBox="1"/>
          <p:nvPr/>
        </p:nvSpPr>
        <p:spPr>
          <a:xfrm>
            <a:off x="894851" y="829013"/>
            <a:ext cx="5886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(a)</a:t>
            </a:r>
            <a:endParaRPr kumimoji="1" lang="ja-JP" altLang="en-US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E8D91E12-ED66-FA45-AB83-F6C24D382DE5}"/>
              </a:ext>
            </a:extLst>
          </p:cNvPr>
          <p:cNvSpPr/>
          <p:nvPr/>
        </p:nvSpPr>
        <p:spPr>
          <a:xfrm>
            <a:off x="77255" y="6488668"/>
            <a:ext cx="370005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Supplementary Figure S4a</a:t>
            </a:r>
            <a:r>
              <a:rPr lang="ja-JP" altLang="ja-JP" b="1">
                <a:latin typeface="Verdana" panose="020B0604030504040204" pitchFamily="34" charset="0"/>
                <a:cs typeface="Verdana" panose="020B0604030504040204" pitchFamily="34" charset="0"/>
              </a:rPr>
              <a:t> </a:t>
            </a:r>
            <a:endParaRPr lang="ja-JP" altLang="en-US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7748877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76869A72-77DB-F345-B41E-FBEECEB6842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42036" y="138222"/>
            <a:ext cx="7805877" cy="6528391"/>
          </a:xfrm>
          <a:prstGeom prst="rect">
            <a:avLst/>
          </a:prstGeom>
        </p:spPr>
      </p:pic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13A904F0-2DE5-1543-95B0-75C865340696}"/>
              </a:ext>
            </a:extLst>
          </p:cNvPr>
          <p:cNvSpPr/>
          <p:nvPr/>
        </p:nvSpPr>
        <p:spPr>
          <a:xfrm>
            <a:off x="77255" y="6488668"/>
            <a:ext cx="370806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Supplementary Figure S4b</a:t>
            </a:r>
            <a:r>
              <a:rPr lang="ja-JP" altLang="ja-JP" b="1">
                <a:latin typeface="Verdana" panose="020B0604030504040204" pitchFamily="34" charset="0"/>
                <a:cs typeface="Verdana" panose="020B0604030504040204" pitchFamily="34" charset="0"/>
              </a:rPr>
              <a:t> </a:t>
            </a:r>
            <a:endParaRPr lang="ja-JP" altLang="en-US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6108039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EB947874-809B-6448-A35E-6C64162AC4B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51272" y="866285"/>
            <a:ext cx="9057463" cy="5239394"/>
          </a:xfrm>
          <a:prstGeom prst="rect">
            <a:avLst/>
          </a:prstGeom>
        </p:spPr>
      </p:pic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A4B9E630-C074-A944-A43E-4F3D2F0EA61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56293170"/>
              </p:ext>
            </p:extLst>
          </p:nvPr>
        </p:nvGraphicFramePr>
        <p:xfrm>
          <a:off x="202018" y="1220714"/>
          <a:ext cx="2081892" cy="4860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081892">
                  <a:extLst>
                    <a:ext uri="{9D8B030D-6E8A-4147-A177-3AD203B41FA5}">
                      <a16:colId xmlns:a16="http://schemas.microsoft.com/office/drawing/2014/main" val="1915209275"/>
                    </a:ext>
                  </a:extLst>
                </a:gridCol>
              </a:tblGrid>
              <a:tr h="324000">
                <a:tc>
                  <a:txBody>
                    <a:bodyPr/>
                    <a:lstStyle/>
                    <a:p>
                      <a:pPr algn="r" fontAlgn="ctr"/>
                      <a:r>
                        <a:rPr lang="en" sz="900" b="1" u="none" strike="noStrike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Cardiovascular diseases</a:t>
                      </a:r>
                      <a:endParaRPr lang="en" sz="900" b="1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7845" marR="7845" marT="784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44892905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r" fontAlgn="ctr"/>
                      <a:r>
                        <a:rPr lang="en" sz="900" b="1" u="none" strike="noStrike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Hepatic diseases</a:t>
                      </a:r>
                      <a:endParaRPr lang="en" sz="900" b="1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7845" marR="7845" marT="784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95714516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r" fontAlgn="ctr"/>
                      <a:r>
                        <a:rPr lang="en" sz="900" b="1" u="none" strike="noStrike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Functional gastrointestinal disorders</a:t>
                      </a:r>
                      <a:endParaRPr lang="en" sz="900" b="1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7845" marR="7845" marT="784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0229046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r" fontAlgn="ctr"/>
                      <a:r>
                        <a:rPr lang="en" sz="900" b="1" u="none" strike="noStrike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Endocrine diseases</a:t>
                      </a:r>
                      <a:endParaRPr lang="en" sz="900" b="1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7845" marR="7845" marT="784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24754887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r" fontAlgn="ctr"/>
                      <a:r>
                        <a:rPr lang="en" sz="900" b="1" u="none" strike="noStrike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Neurological diseases</a:t>
                      </a:r>
                      <a:endParaRPr lang="en" sz="900" b="1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7845" marR="7845" marT="784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66803371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r" fontAlgn="ctr"/>
                      <a:r>
                        <a:rPr lang="en" sz="900" b="1" u="none" strike="noStrike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Psychiatric diseases</a:t>
                      </a:r>
                      <a:endParaRPr lang="en" sz="900" b="1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7845" marR="7845" marT="784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73201057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r" fontAlgn="ctr"/>
                      <a:r>
                        <a:rPr lang="en" sz="900" b="1" u="none" strike="noStrike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Inflammatory Bowel Diseases (IBD)</a:t>
                      </a:r>
                      <a:endParaRPr lang="en" sz="900" b="1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7845" marR="7845" marT="784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00089311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r" fontAlgn="ctr"/>
                      <a:r>
                        <a:rPr lang="en" sz="900" b="1" u="none" strike="noStrike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Autoimmune diseases</a:t>
                      </a:r>
                      <a:endParaRPr lang="en" sz="900" b="1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7845" marR="7845" marT="784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0844140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r" fontAlgn="ctr"/>
                      <a:r>
                        <a:rPr lang="en" sz="900" b="1" u="none" strike="noStrike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Malignant diseases </a:t>
                      </a:r>
                      <a:br>
                        <a:rPr lang="en" sz="900" b="1" u="none" strike="noStrike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</a:br>
                      <a:r>
                        <a:rPr lang="en" sz="900" b="1" u="none" strike="noStrike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(under treatment)</a:t>
                      </a:r>
                      <a:endParaRPr lang="en" sz="900" b="1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7845" marR="7845" marT="784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88329415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r" fontAlgn="ctr"/>
                      <a:r>
                        <a:rPr lang="en" sz="900" b="1" u="none" strike="noStrike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Malignant diseases </a:t>
                      </a:r>
                      <a:br>
                        <a:rPr lang="en" sz="900" b="1" u="none" strike="noStrike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</a:br>
                      <a:r>
                        <a:rPr lang="en" sz="900" b="1" u="none" strike="noStrike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(after treatment)</a:t>
                      </a:r>
                      <a:endParaRPr lang="en" sz="900" b="1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7845" marR="7845" marT="784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83479583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r" fontAlgn="ctr"/>
                      <a:r>
                        <a:rPr lang="en" sz="900" b="1" u="none" strike="noStrike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Hypertension</a:t>
                      </a:r>
                      <a:endParaRPr lang="en" sz="900" b="1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7845" marR="7845" marT="784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74055016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r" fontAlgn="ctr"/>
                      <a:r>
                        <a:rPr lang="en" sz="900" b="1" u="none" strike="noStrike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Dyslipidemia</a:t>
                      </a:r>
                      <a:endParaRPr lang="en" sz="900" b="1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7845" marR="7845" marT="784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22932292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r" fontAlgn="ctr"/>
                      <a:r>
                        <a:rPr lang="en" sz="900" b="1" u="none" strike="noStrike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Hyperuricemia</a:t>
                      </a:r>
                      <a:endParaRPr lang="en" sz="900" b="1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7845" marR="7845" marT="784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15199178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r" fontAlgn="ctr"/>
                      <a:r>
                        <a:rPr lang="en" sz="900" b="1" u="none" strike="noStrike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Diabetes</a:t>
                      </a:r>
                      <a:endParaRPr lang="en" sz="900" b="1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7845" marR="7845" marT="784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26733278"/>
                  </a:ext>
                </a:extLst>
              </a:tr>
              <a:tr h="324000">
                <a:tc>
                  <a:txBody>
                    <a:bodyPr/>
                    <a:lstStyle/>
                    <a:p>
                      <a:pPr algn="r" fontAlgn="ctr"/>
                      <a:r>
                        <a:rPr lang="en" sz="900" b="1" u="none" strike="noStrike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Obesities </a:t>
                      </a:r>
                      <a:br>
                        <a:rPr lang="en" sz="900" b="1" u="none" strike="noStrike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</a:br>
                      <a:r>
                        <a:rPr lang="en" sz="900" b="1" u="none" strike="noStrike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(BMI ≥ 30 kg/m</a:t>
                      </a:r>
                      <a:r>
                        <a:rPr lang="en" sz="900" b="1" u="none" strike="noStrike" baseline="30000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2</a:t>
                      </a:r>
                      <a:r>
                        <a:rPr lang="en" sz="900" b="1" u="none" strike="noStrike" dirty="0">
                          <a:effectLst/>
                          <a:latin typeface="Verdana" panose="020B0604030504040204" pitchFamily="34" charset="0"/>
                          <a:ea typeface="Verdana" panose="020B0604030504040204" pitchFamily="34" charset="0"/>
                          <a:cs typeface="Verdana" panose="020B0604030504040204" pitchFamily="34" charset="0"/>
                        </a:rPr>
                        <a:t>)</a:t>
                      </a:r>
                      <a:endParaRPr lang="en" sz="900" b="1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Verdana" panose="020B0604030504040204" pitchFamily="34" charset="0"/>
                        <a:cs typeface="Verdana" panose="020B0604030504040204" pitchFamily="34" charset="0"/>
                      </a:endParaRPr>
                    </a:p>
                  </a:txBody>
                  <a:tcPr marL="7845" marR="7845" marT="784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7361812"/>
                  </a:ext>
                </a:extLst>
              </a:tr>
            </a:tbl>
          </a:graphicData>
        </a:graphic>
      </p:graphicFrame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55543F1B-C098-D147-90CC-A69D98AFB6DB}"/>
              </a:ext>
            </a:extLst>
          </p:cNvPr>
          <p:cNvSpPr/>
          <p:nvPr/>
        </p:nvSpPr>
        <p:spPr>
          <a:xfrm>
            <a:off x="88685" y="6488668"/>
            <a:ext cx="354616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Supplementary Figure S5</a:t>
            </a:r>
            <a:r>
              <a:rPr lang="ja-JP" altLang="ja-JP" b="1">
                <a:latin typeface="Verdana" panose="020B0604030504040204" pitchFamily="34" charset="0"/>
                <a:cs typeface="Verdana" panose="020B0604030504040204" pitchFamily="34" charset="0"/>
              </a:rPr>
              <a:t> </a:t>
            </a:r>
            <a:endParaRPr lang="ja-JP" altLang="en-US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5158253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14A64BBC-C784-2549-99B3-5E3F44049D4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828" t="4280" r="11873" b="4833"/>
          <a:stretch/>
        </p:blipFill>
        <p:spPr>
          <a:xfrm>
            <a:off x="1872208" y="279101"/>
            <a:ext cx="3401541" cy="2713038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856798A-A3EE-6547-BFC8-1983FC03A954}"/>
              </a:ext>
            </a:extLst>
          </p:cNvPr>
          <p:cNvSpPr txBox="1"/>
          <p:nvPr/>
        </p:nvSpPr>
        <p:spPr>
          <a:xfrm>
            <a:off x="2857168" y="173923"/>
            <a:ext cx="2567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k</a:t>
            </a:r>
            <a:endParaRPr kumimoji="1" lang="ja-JP" altLang="en-US" sz="800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B6D48132-D9BF-334B-BB3D-124E5F459992}"/>
              </a:ext>
            </a:extLst>
          </p:cNvPr>
          <p:cNvSpPr txBox="1"/>
          <p:nvPr/>
        </p:nvSpPr>
        <p:spPr>
          <a:xfrm>
            <a:off x="3268887" y="250884"/>
            <a:ext cx="2567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d</a:t>
            </a:r>
            <a:endParaRPr kumimoji="1" lang="ja-JP" altLang="en-US" sz="800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BF032BAB-1DC4-5643-B00C-E33AB8CD5006}"/>
              </a:ext>
            </a:extLst>
          </p:cNvPr>
          <p:cNvSpPr txBox="1"/>
          <p:nvPr/>
        </p:nvSpPr>
        <p:spPr>
          <a:xfrm>
            <a:off x="4060345" y="787666"/>
            <a:ext cx="4939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c,d</a:t>
            </a:r>
            <a:endParaRPr kumimoji="1" lang="ja-JP" altLang="en-US" sz="800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CDBFF45C-0A1B-914A-8665-793D8423F947}"/>
              </a:ext>
            </a:extLst>
          </p:cNvPr>
          <p:cNvSpPr txBox="1"/>
          <p:nvPr/>
        </p:nvSpPr>
        <p:spPr>
          <a:xfrm>
            <a:off x="2384677" y="509613"/>
            <a:ext cx="4542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c,d</a:t>
            </a:r>
            <a:endParaRPr kumimoji="1" lang="ja-JP" altLang="en-US" sz="800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3BA89C71-4BD7-6D48-8A31-874F2B78F9C2}"/>
              </a:ext>
            </a:extLst>
          </p:cNvPr>
          <p:cNvSpPr txBox="1"/>
          <p:nvPr/>
        </p:nvSpPr>
        <p:spPr>
          <a:xfrm>
            <a:off x="3005024" y="428780"/>
            <a:ext cx="5285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c,e</a:t>
            </a:r>
            <a:endParaRPr kumimoji="1" lang="ja-JP" altLang="en-US" sz="800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01B97AC1-FFDB-DC41-B42D-E6EC97A8EEE5}"/>
              </a:ext>
            </a:extLst>
          </p:cNvPr>
          <p:cNvSpPr txBox="1"/>
          <p:nvPr/>
        </p:nvSpPr>
        <p:spPr>
          <a:xfrm>
            <a:off x="4478102" y="884967"/>
            <a:ext cx="3850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e,f</a:t>
            </a:r>
            <a:endParaRPr kumimoji="1" lang="ja-JP" altLang="en-US" sz="800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D3CC2BD5-B085-1F49-8547-BEC1E105561E}"/>
              </a:ext>
            </a:extLst>
          </p:cNvPr>
          <p:cNvSpPr txBox="1"/>
          <p:nvPr/>
        </p:nvSpPr>
        <p:spPr>
          <a:xfrm>
            <a:off x="3624868" y="788013"/>
            <a:ext cx="3850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b="1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b,</a:t>
            </a:r>
            <a:r>
              <a:rPr kumimoji="1" lang="en-US" altLang="ja-JP" sz="800" b="1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f</a:t>
            </a:r>
            <a:endParaRPr kumimoji="1" lang="ja-JP" altLang="en-US" sz="800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90AA0A5B-167C-7942-9426-3AA7914E2189}"/>
              </a:ext>
            </a:extLst>
          </p:cNvPr>
          <p:cNvSpPr txBox="1"/>
          <p:nvPr/>
        </p:nvSpPr>
        <p:spPr>
          <a:xfrm>
            <a:off x="3840196" y="1174163"/>
            <a:ext cx="4588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a,b</a:t>
            </a:r>
            <a:endParaRPr kumimoji="1" lang="ja-JP" altLang="en-US" sz="800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20E8F087-76EC-5B48-A8CB-655AD9D9C65D}"/>
              </a:ext>
            </a:extLst>
          </p:cNvPr>
          <p:cNvSpPr txBox="1"/>
          <p:nvPr/>
        </p:nvSpPr>
        <p:spPr>
          <a:xfrm>
            <a:off x="1999580" y="1190920"/>
            <a:ext cx="3850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a,j</a:t>
            </a:r>
            <a:endParaRPr kumimoji="1" lang="ja-JP" altLang="en-US" sz="800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D7ED069A-E98A-9A40-AA76-7DD1D9098481}"/>
              </a:ext>
            </a:extLst>
          </p:cNvPr>
          <p:cNvSpPr txBox="1"/>
          <p:nvPr/>
        </p:nvSpPr>
        <p:spPr>
          <a:xfrm>
            <a:off x="3350600" y="1388938"/>
            <a:ext cx="5976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a,h,j</a:t>
            </a:r>
            <a:endParaRPr kumimoji="1" lang="ja-JP" altLang="en-US" sz="800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8541F4DC-8FF9-284F-AD05-4D83ADCF36A1}"/>
              </a:ext>
            </a:extLst>
          </p:cNvPr>
          <p:cNvSpPr txBox="1"/>
          <p:nvPr/>
        </p:nvSpPr>
        <p:spPr>
          <a:xfrm>
            <a:off x="2589926" y="1439569"/>
            <a:ext cx="3850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h,j</a:t>
            </a:r>
            <a:endParaRPr kumimoji="1" lang="ja-JP" altLang="en-US" sz="800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9675BCD2-0F5B-0842-9C57-7FD7908C3BE6}"/>
              </a:ext>
            </a:extLst>
          </p:cNvPr>
          <p:cNvSpPr txBox="1"/>
          <p:nvPr/>
        </p:nvSpPr>
        <p:spPr>
          <a:xfrm>
            <a:off x="4664029" y="1617403"/>
            <a:ext cx="4652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b="1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g,h</a:t>
            </a:r>
            <a:endParaRPr kumimoji="1" lang="ja-JP" altLang="en-US" sz="800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DD403156-E737-9944-91C8-EDE347D0BCE4}"/>
              </a:ext>
            </a:extLst>
          </p:cNvPr>
          <p:cNvSpPr txBox="1"/>
          <p:nvPr/>
        </p:nvSpPr>
        <p:spPr>
          <a:xfrm>
            <a:off x="2210153" y="1627932"/>
            <a:ext cx="3850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g</a:t>
            </a:r>
            <a:endParaRPr kumimoji="1" lang="ja-JP" altLang="en-US" sz="800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CB1F44C6-508E-7247-B23B-91B7ECABD1E8}"/>
              </a:ext>
            </a:extLst>
          </p:cNvPr>
          <p:cNvSpPr txBox="1"/>
          <p:nvPr/>
        </p:nvSpPr>
        <p:spPr>
          <a:xfrm>
            <a:off x="4954856" y="1500990"/>
            <a:ext cx="3850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i</a:t>
            </a:r>
            <a:endParaRPr kumimoji="1" lang="ja-JP" altLang="en-US" sz="800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3AAA2F71-FC7E-A94C-BF02-14E6BF8645EF}"/>
              </a:ext>
            </a:extLst>
          </p:cNvPr>
          <p:cNvSpPr txBox="1"/>
          <p:nvPr/>
        </p:nvSpPr>
        <p:spPr>
          <a:xfrm>
            <a:off x="4250112" y="634101"/>
            <a:ext cx="4636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c,d</a:t>
            </a:r>
            <a:endParaRPr kumimoji="1" lang="ja-JP" altLang="en-US" sz="800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F56DDA64-2B32-5048-92F2-A98A6FA48736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984" t="3420" r="11711" b="4831"/>
          <a:stretch/>
        </p:blipFill>
        <p:spPr>
          <a:xfrm>
            <a:off x="6506824" y="250305"/>
            <a:ext cx="3324748" cy="2743201"/>
          </a:xfrm>
          <a:prstGeom prst="rect">
            <a:avLst/>
          </a:prstGeom>
        </p:spPr>
      </p:pic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B1422AC8-1865-C046-89EC-BCB2B0261DBE}"/>
              </a:ext>
            </a:extLst>
          </p:cNvPr>
          <p:cNvSpPr txBox="1"/>
          <p:nvPr/>
        </p:nvSpPr>
        <p:spPr>
          <a:xfrm>
            <a:off x="7400683" y="187021"/>
            <a:ext cx="2567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i</a:t>
            </a:r>
            <a:endParaRPr kumimoji="1" lang="ja-JP" altLang="en-US" sz="800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85387339-AD8F-0441-A703-CB8D0AE33CC8}"/>
              </a:ext>
            </a:extLst>
          </p:cNvPr>
          <p:cNvSpPr txBox="1"/>
          <p:nvPr/>
        </p:nvSpPr>
        <p:spPr>
          <a:xfrm>
            <a:off x="6935884" y="213277"/>
            <a:ext cx="4135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d,e</a:t>
            </a:r>
            <a:endParaRPr kumimoji="1" lang="ja-JP" altLang="en-US" sz="800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B1BBD6E1-20A2-374C-B201-B57FA6F65DE3}"/>
              </a:ext>
            </a:extLst>
          </p:cNvPr>
          <p:cNvSpPr txBox="1"/>
          <p:nvPr/>
        </p:nvSpPr>
        <p:spPr>
          <a:xfrm>
            <a:off x="8770046" y="351831"/>
            <a:ext cx="6303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b="1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b</a:t>
            </a:r>
            <a:r>
              <a:rPr kumimoji="1" lang="en-US" altLang="ja-JP" sz="800" b="1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,d,e</a:t>
            </a:r>
            <a:endParaRPr kumimoji="1" lang="ja-JP" altLang="en-US" sz="800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953ACC70-EAE4-1D41-B2B2-8C0340D097EE}"/>
              </a:ext>
            </a:extLst>
          </p:cNvPr>
          <p:cNvSpPr txBox="1"/>
          <p:nvPr/>
        </p:nvSpPr>
        <p:spPr>
          <a:xfrm>
            <a:off x="7497638" y="272680"/>
            <a:ext cx="5405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b,</a:t>
            </a:r>
            <a:r>
              <a:rPr lang="en-US" altLang="ja-JP" sz="800" b="1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c,d</a:t>
            </a:r>
            <a:endParaRPr kumimoji="1" lang="ja-JP" altLang="en-US" sz="800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E6A7BBDC-277E-0748-87B9-F0B4EE83312F}"/>
              </a:ext>
            </a:extLst>
          </p:cNvPr>
          <p:cNvSpPr txBox="1"/>
          <p:nvPr/>
        </p:nvSpPr>
        <p:spPr>
          <a:xfrm>
            <a:off x="8607573" y="245194"/>
            <a:ext cx="4153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b="1" dirty="0" err="1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b,c</a:t>
            </a:r>
            <a:endParaRPr kumimoji="1" lang="ja-JP" altLang="en-US" sz="800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775C5334-F46D-E74B-B870-3ECC185967B3}"/>
              </a:ext>
            </a:extLst>
          </p:cNvPr>
          <p:cNvSpPr txBox="1"/>
          <p:nvPr/>
        </p:nvSpPr>
        <p:spPr>
          <a:xfrm>
            <a:off x="8238062" y="370485"/>
            <a:ext cx="243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c</a:t>
            </a:r>
            <a:endParaRPr kumimoji="1" lang="ja-JP" altLang="en-US" sz="800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320B7592-997B-2D4C-B6D2-AA70F9BB71F2}"/>
              </a:ext>
            </a:extLst>
          </p:cNvPr>
          <p:cNvSpPr txBox="1"/>
          <p:nvPr/>
        </p:nvSpPr>
        <p:spPr>
          <a:xfrm>
            <a:off x="8451289" y="438149"/>
            <a:ext cx="243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a</a:t>
            </a:r>
            <a:endParaRPr kumimoji="1" lang="ja-JP" altLang="en-US" sz="800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24C0E811-BC6F-5A4B-969C-FE809789A727}"/>
              </a:ext>
            </a:extLst>
          </p:cNvPr>
          <p:cNvSpPr txBox="1"/>
          <p:nvPr/>
        </p:nvSpPr>
        <p:spPr>
          <a:xfrm>
            <a:off x="9084137" y="450849"/>
            <a:ext cx="243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a</a:t>
            </a:r>
            <a:endParaRPr kumimoji="1" lang="ja-JP" altLang="en-US" sz="800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B1A8FEB5-C0F9-F249-8180-3C305DB6E4A9}"/>
              </a:ext>
            </a:extLst>
          </p:cNvPr>
          <p:cNvSpPr txBox="1"/>
          <p:nvPr/>
        </p:nvSpPr>
        <p:spPr>
          <a:xfrm>
            <a:off x="6801214" y="523498"/>
            <a:ext cx="243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f</a:t>
            </a:r>
            <a:endParaRPr kumimoji="1" lang="ja-JP" altLang="en-US" sz="800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9D7C0201-29C1-4143-A6AA-6256C2181067}"/>
              </a:ext>
            </a:extLst>
          </p:cNvPr>
          <p:cNvSpPr txBox="1"/>
          <p:nvPr/>
        </p:nvSpPr>
        <p:spPr>
          <a:xfrm>
            <a:off x="7201408" y="522256"/>
            <a:ext cx="243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h</a:t>
            </a:r>
            <a:endParaRPr kumimoji="1" lang="ja-JP" altLang="en-US" sz="800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EEF08B35-F222-EE4F-BF42-DD46E2684592}"/>
              </a:ext>
            </a:extLst>
          </p:cNvPr>
          <p:cNvSpPr txBox="1"/>
          <p:nvPr/>
        </p:nvSpPr>
        <p:spPr>
          <a:xfrm>
            <a:off x="8036086" y="523847"/>
            <a:ext cx="2677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h</a:t>
            </a:r>
            <a:endParaRPr kumimoji="1" lang="ja-JP" altLang="en-US" sz="800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165EC956-F037-3B48-B27D-ED246CD922CC}"/>
              </a:ext>
            </a:extLst>
          </p:cNvPr>
          <p:cNvSpPr txBox="1"/>
          <p:nvPr/>
        </p:nvSpPr>
        <p:spPr>
          <a:xfrm>
            <a:off x="9309938" y="555575"/>
            <a:ext cx="243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f</a:t>
            </a:r>
            <a:endParaRPr kumimoji="1" lang="ja-JP" altLang="en-US" sz="800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408E8ABB-0AFF-264D-A6FA-0B2ADFBC1D64}"/>
              </a:ext>
            </a:extLst>
          </p:cNvPr>
          <p:cNvSpPr txBox="1"/>
          <p:nvPr/>
        </p:nvSpPr>
        <p:spPr>
          <a:xfrm>
            <a:off x="9498016" y="739581"/>
            <a:ext cx="243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g</a:t>
            </a:r>
            <a:endParaRPr kumimoji="1" lang="ja-JP" altLang="en-US" sz="800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99052F22-BC5D-EA42-8204-638AE97F3655}"/>
              </a:ext>
            </a:extLst>
          </p:cNvPr>
          <p:cNvSpPr txBox="1"/>
          <p:nvPr/>
        </p:nvSpPr>
        <p:spPr>
          <a:xfrm>
            <a:off x="6584357" y="325837"/>
            <a:ext cx="2433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a</a:t>
            </a:r>
            <a:endParaRPr kumimoji="1" lang="ja-JP" altLang="en-US" sz="800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C614ADE6-65D8-6042-84BC-065C3FA24F89}"/>
              </a:ext>
            </a:extLst>
          </p:cNvPr>
          <p:cNvSpPr txBox="1"/>
          <p:nvPr/>
        </p:nvSpPr>
        <p:spPr>
          <a:xfrm>
            <a:off x="7825566" y="292493"/>
            <a:ext cx="2567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e</a:t>
            </a:r>
            <a:endParaRPr kumimoji="1" lang="ja-JP" altLang="en-US" sz="800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pic>
        <p:nvPicPr>
          <p:cNvPr id="50" name="図 49">
            <a:extLst>
              <a:ext uri="{FF2B5EF4-FFF2-40B4-BE49-F238E27FC236}">
                <a16:creationId xmlns:a16="http://schemas.microsoft.com/office/drawing/2014/main" id="{F9B54EED-AF52-FC49-A753-C9A84AB08B7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6190"/>
          <a:stretch/>
        </p:blipFill>
        <p:spPr>
          <a:xfrm>
            <a:off x="1844990" y="3785189"/>
            <a:ext cx="3459191" cy="2633873"/>
          </a:xfrm>
          <a:prstGeom prst="rect">
            <a:avLst/>
          </a:prstGeom>
        </p:spPr>
      </p:pic>
      <p:pic>
        <p:nvPicPr>
          <p:cNvPr id="51" name="図 50">
            <a:extLst>
              <a:ext uri="{FF2B5EF4-FFF2-40B4-BE49-F238E27FC236}">
                <a16:creationId xmlns:a16="http://schemas.microsoft.com/office/drawing/2014/main" id="{433A3607-1467-BC41-8E5B-8F41D89C5C2D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r="6197"/>
          <a:stretch/>
        </p:blipFill>
        <p:spPr>
          <a:xfrm>
            <a:off x="6461137" y="3779152"/>
            <a:ext cx="3458936" cy="2633873"/>
          </a:xfrm>
          <a:prstGeom prst="rect">
            <a:avLst/>
          </a:prstGeom>
        </p:spPr>
      </p:pic>
      <p:sp>
        <p:nvSpPr>
          <p:cNvPr id="53" name="正方形/長方形 52">
            <a:extLst>
              <a:ext uri="{FF2B5EF4-FFF2-40B4-BE49-F238E27FC236}">
                <a16:creationId xmlns:a16="http://schemas.microsoft.com/office/drawing/2014/main" id="{00BCEC96-DCC8-7544-8F98-4D4CD1D9B5E1}"/>
              </a:ext>
            </a:extLst>
          </p:cNvPr>
          <p:cNvSpPr/>
          <p:nvPr/>
        </p:nvSpPr>
        <p:spPr>
          <a:xfrm>
            <a:off x="77255" y="6488668"/>
            <a:ext cx="354616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Supplementary </a:t>
            </a:r>
            <a:r>
              <a:rPr lang="en-US" altLang="ja-JP" b="1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Figure S6</a:t>
            </a:r>
            <a:r>
              <a:rPr lang="ja-JP" altLang="ja-JP" b="1">
                <a:latin typeface="Verdana" panose="020B0604030504040204" pitchFamily="34" charset="0"/>
                <a:cs typeface="Verdana" panose="020B0604030504040204" pitchFamily="34" charset="0"/>
              </a:rPr>
              <a:t> </a:t>
            </a:r>
            <a:endParaRPr lang="ja-JP" altLang="en-US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pic>
        <p:nvPicPr>
          <p:cNvPr id="54" name="図 53">
            <a:extLst>
              <a:ext uri="{FF2B5EF4-FFF2-40B4-BE49-F238E27FC236}">
                <a16:creationId xmlns:a16="http://schemas.microsoft.com/office/drawing/2014/main" id="{900FD05E-9AF7-7040-92B0-9B386DD2F57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87608" t="26647" r="-169" b="22855"/>
          <a:stretch/>
        </p:blipFill>
        <p:spPr>
          <a:xfrm>
            <a:off x="9900971" y="536979"/>
            <a:ext cx="720803" cy="2380327"/>
          </a:xfrm>
          <a:prstGeom prst="rect">
            <a:avLst/>
          </a:prstGeom>
        </p:spPr>
      </p:pic>
      <p:pic>
        <p:nvPicPr>
          <p:cNvPr id="55" name="図 54">
            <a:extLst>
              <a:ext uri="{FF2B5EF4-FFF2-40B4-BE49-F238E27FC236}">
                <a16:creationId xmlns:a16="http://schemas.microsoft.com/office/drawing/2014/main" id="{9DA56CDA-4BD2-A14E-8661-B175B0EC6EE0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93425" t="32692" r="57" b="30417"/>
          <a:stretch/>
        </p:blipFill>
        <p:spPr>
          <a:xfrm>
            <a:off x="10029008" y="3763241"/>
            <a:ext cx="677978" cy="2741390"/>
          </a:xfrm>
          <a:prstGeom prst="rect">
            <a:avLst/>
          </a:prstGeom>
        </p:spPr>
      </p:pic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28947DBC-A83A-1941-BA94-A91BAEA78B2C}"/>
              </a:ext>
            </a:extLst>
          </p:cNvPr>
          <p:cNvSpPr txBox="1"/>
          <p:nvPr/>
        </p:nvSpPr>
        <p:spPr>
          <a:xfrm>
            <a:off x="1332400" y="84734"/>
            <a:ext cx="5886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(a)</a:t>
            </a:r>
            <a:endParaRPr kumimoji="1" lang="ja-JP" altLang="en-US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0EC32C93-244F-1E4F-8571-32A60F7AA06E}"/>
              </a:ext>
            </a:extLst>
          </p:cNvPr>
          <p:cNvSpPr txBox="1"/>
          <p:nvPr/>
        </p:nvSpPr>
        <p:spPr>
          <a:xfrm>
            <a:off x="5834194" y="93826"/>
            <a:ext cx="596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(b)</a:t>
            </a:r>
            <a:endParaRPr kumimoji="1" lang="ja-JP" altLang="en-US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5E7B9BF8-E1C2-0C45-AFCC-BB65CED0DDF2}"/>
              </a:ext>
            </a:extLst>
          </p:cNvPr>
          <p:cNvSpPr txBox="1"/>
          <p:nvPr/>
        </p:nvSpPr>
        <p:spPr>
          <a:xfrm>
            <a:off x="1364299" y="3634957"/>
            <a:ext cx="5709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(c)</a:t>
            </a:r>
            <a:endParaRPr kumimoji="1" lang="ja-JP" altLang="en-US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0E4F0BAA-5108-904C-8700-DFDC3703F8B0}"/>
              </a:ext>
            </a:extLst>
          </p:cNvPr>
          <p:cNvSpPr txBox="1"/>
          <p:nvPr/>
        </p:nvSpPr>
        <p:spPr>
          <a:xfrm>
            <a:off x="5918647" y="3631586"/>
            <a:ext cx="596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(d)</a:t>
            </a:r>
            <a:endParaRPr kumimoji="1" lang="ja-JP" altLang="en-US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E2EB39A6-8722-D44B-800F-B4BF52A8B79F}"/>
              </a:ext>
            </a:extLst>
          </p:cNvPr>
          <p:cNvSpPr txBox="1"/>
          <p:nvPr/>
        </p:nvSpPr>
        <p:spPr>
          <a:xfrm rot="16200000">
            <a:off x="927922" y="1370572"/>
            <a:ext cx="1486304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Chao1 indices</a:t>
            </a:r>
            <a:r>
              <a:rPr lang="ja-JP" altLang="ja-JP" sz="1200" b="1">
                <a:latin typeface="Verdana" panose="020B0604030504040204" pitchFamily="34" charset="0"/>
                <a:cs typeface="Verdana" panose="020B0604030504040204" pitchFamily="34" charset="0"/>
              </a:rPr>
              <a:t> </a:t>
            </a:r>
            <a:endParaRPr kumimoji="1" lang="ja-JP" altLang="en-US" sz="1200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EC677C18-CF70-9E47-B06A-B17776352E36}"/>
              </a:ext>
            </a:extLst>
          </p:cNvPr>
          <p:cNvSpPr txBox="1"/>
          <p:nvPr/>
        </p:nvSpPr>
        <p:spPr>
          <a:xfrm rot="16200000">
            <a:off x="5490381" y="1479992"/>
            <a:ext cx="170271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Shannon indices</a:t>
            </a:r>
            <a:r>
              <a:rPr lang="ja-JP" altLang="ja-JP" sz="1200" b="1">
                <a:latin typeface="Verdana" panose="020B0604030504040204" pitchFamily="34" charset="0"/>
                <a:cs typeface="Verdana" panose="020B0604030504040204" pitchFamily="34" charset="0"/>
              </a:rPr>
              <a:t> </a:t>
            </a:r>
            <a:endParaRPr kumimoji="1" lang="ja-JP" altLang="en-US" sz="1200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598F900B-2F7C-684F-96A2-97A6D6F5F5D0}"/>
              </a:ext>
            </a:extLst>
          </p:cNvPr>
          <p:cNvSpPr txBox="1"/>
          <p:nvPr/>
        </p:nvSpPr>
        <p:spPr>
          <a:xfrm>
            <a:off x="1955129" y="2948361"/>
            <a:ext cx="34227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1  </a:t>
            </a:r>
            <a:r>
              <a:rPr kumimoji="1" lang="en-US" altLang="ja-JP" sz="8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kumimoji="1" lang="en-US" altLang="ja-JP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2   3 </a:t>
            </a:r>
            <a:r>
              <a:rPr kumimoji="1" lang="en-US" altLang="ja-JP" sz="8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 </a:t>
            </a:r>
            <a:r>
              <a:rPr kumimoji="1" lang="en-US" altLang="ja-JP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4 </a:t>
            </a:r>
            <a:r>
              <a:rPr kumimoji="1" lang="en-US" altLang="ja-JP" sz="8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 </a:t>
            </a:r>
            <a:r>
              <a:rPr kumimoji="1" lang="en-US" altLang="ja-JP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5 </a:t>
            </a:r>
            <a:r>
              <a:rPr kumimoji="1" lang="en-US" altLang="ja-JP" sz="8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 </a:t>
            </a:r>
            <a:r>
              <a:rPr kumimoji="1" lang="en-US" altLang="ja-JP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6 </a:t>
            </a:r>
            <a:r>
              <a:rPr kumimoji="1" lang="en-US" altLang="ja-JP" sz="8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 </a:t>
            </a:r>
            <a:r>
              <a:rPr kumimoji="1" lang="en-US" altLang="ja-JP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7</a:t>
            </a:r>
            <a:r>
              <a:rPr lang="en-US" altLang="ja-JP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kumimoji="1" lang="en-US" altLang="ja-JP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kumimoji="1" lang="en-US" altLang="ja-JP" sz="8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kumimoji="1" lang="en-US" altLang="ja-JP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8  </a:t>
            </a:r>
            <a:r>
              <a:rPr kumimoji="1" lang="en-US" altLang="ja-JP" sz="8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kumimoji="1" lang="en-US" altLang="ja-JP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9 </a:t>
            </a:r>
            <a:r>
              <a:rPr kumimoji="1" lang="en-US" altLang="ja-JP" sz="8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lang="en-US" altLang="ja-JP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</a:t>
            </a:r>
            <a:r>
              <a:rPr lang="en-US" altLang="ja-JP" sz="8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lang="en-US" altLang="ja-JP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1</a:t>
            </a:r>
            <a:r>
              <a:rPr lang="en-US" altLang="ja-JP" sz="8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lang="en-US" altLang="ja-JP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2</a:t>
            </a:r>
            <a:r>
              <a:rPr lang="en-US" altLang="ja-JP" sz="8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lang="en-US" altLang="ja-JP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3</a:t>
            </a:r>
            <a:r>
              <a:rPr lang="en-US" altLang="ja-JP" sz="8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lang="en-US" altLang="ja-JP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4</a:t>
            </a:r>
            <a:r>
              <a:rPr lang="en-US" altLang="ja-JP" sz="8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lang="en-US" altLang="ja-JP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5</a:t>
            </a:r>
            <a:endParaRPr kumimoji="1" lang="ja-JP" altLang="en-US" sz="1000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cxnSp>
        <p:nvCxnSpPr>
          <p:cNvPr id="63" name="直線コネクタ 62">
            <a:extLst>
              <a:ext uri="{FF2B5EF4-FFF2-40B4-BE49-F238E27FC236}">
                <a16:creationId xmlns:a16="http://schemas.microsoft.com/office/drawing/2014/main" id="{1510890D-C25C-004F-B7E8-C12C012A9808}"/>
              </a:ext>
            </a:extLst>
          </p:cNvPr>
          <p:cNvCxnSpPr>
            <a:cxnSpLocks/>
          </p:cNvCxnSpPr>
          <p:nvPr/>
        </p:nvCxnSpPr>
        <p:spPr>
          <a:xfrm>
            <a:off x="2021613" y="3213851"/>
            <a:ext cx="3184797" cy="0"/>
          </a:xfrm>
          <a:prstGeom prst="line">
            <a:avLst/>
          </a:prstGeom>
          <a:ln w="15875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88F30340-E20F-A243-A7C2-F532B808E0BD}"/>
              </a:ext>
            </a:extLst>
          </p:cNvPr>
          <p:cNvSpPr txBox="1"/>
          <p:nvPr/>
        </p:nvSpPr>
        <p:spPr>
          <a:xfrm>
            <a:off x="3090793" y="3188514"/>
            <a:ext cx="689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T</a:t>
            </a:r>
            <a:r>
              <a:rPr kumimoji="1" lang="en-US" altLang="ja-JP" sz="12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ypes</a:t>
            </a:r>
            <a:endParaRPr kumimoji="1" lang="ja-JP" altLang="en-US" sz="1200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94FC9C4F-8951-0B45-AEB3-BDEC967EE433}"/>
              </a:ext>
            </a:extLst>
          </p:cNvPr>
          <p:cNvSpPr txBox="1"/>
          <p:nvPr/>
        </p:nvSpPr>
        <p:spPr>
          <a:xfrm>
            <a:off x="6516495" y="2956002"/>
            <a:ext cx="34227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1  </a:t>
            </a:r>
            <a:r>
              <a:rPr kumimoji="1" lang="en-US" altLang="ja-JP" sz="8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kumimoji="1" lang="en-US" altLang="ja-JP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2   3 </a:t>
            </a:r>
            <a:r>
              <a:rPr kumimoji="1" lang="en-US" altLang="ja-JP" sz="8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 </a:t>
            </a:r>
            <a:r>
              <a:rPr kumimoji="1" lang="en-US" altLang="ja-JP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4 </a:t>
            </a:r>
            <a:r>
              <a:rPr kumimoji="1" lang="en-US" altLang="ja-JP" sz="8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 </a:t>
            </a:r>
            <a:r>
              <a:rPr kumimoji="1" lang="en-US" altLang="ja-JP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5 </a:t>
            </a:r>
            <a:r>
              <a:rPr kumimoji="1" lang="en-US" altLang="ja-JP" sz="8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 </a:t>
            </a:r>
            <a:r>
              <a:rPr kumimoji="1" lang="en-US" altLang="ja-JP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6 </a:t>
            </a:r>
            <a:r>
              <a:rPr kumimoji="1" lang="en-US" altLang="ja-JP" sz="8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 </a:t>
            </a:r>
            <a:r>
              <a:rPr kumimoji="1" lang="en-US" altLang="ja-JP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7</a:t>
            </a:r>
            <a:r>
              <a:rPr lang="en-US" altLang="ja-JP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kumimoji="1" lang="en-US" altLang="ja-JP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kumimoji="1" lang="en-US" altLang="ja-JP" sz="8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kumimoji="1" lang="en-US" altLang="ja-JP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8  </a:t>
            </a:r>
            <a:r>
              <a:rPr kumimoji="1" lang="en-US" altLang="ja-JP" sz="8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kumimoji="1" lang="en-US" altLang="ja-JP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9 </a:t>
            </a:r>
            <a:r>
              <a:rPr kumimoji="1" lang="en-US" altLang="ja-JP" sz="8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lang="en-US" altLang="ja-JP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0</a:t>
            </a:r>
            <a:r>
              <a:rPr lang="en-US" altLang="ja-JP" sz="8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lang="en-US" altLang="ja-JP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1</a:t>
            </a:r>
            <a:r>
              <a:rPr lang="en-US" altLang="ja-JP" sz="8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lang="en-US" altLang="ja-JP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2</a:t>
            </a:r>
            <a:r>
              <a:rPr lang="en-US" altLang="ja-JP" sz="8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lang="en-US" altLang="ja-JP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3</a:t>
            </a:r>
            <a:r>
              <a:rPr lang="en-US" altLang="ja-JP" sz="8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lang="en-US" altLang="ja-JP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4</a:t>
            </a:r>
            <a:r>
              <a:rPr lang="en-US" altLang="ja-JP" sz="8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</a:t>
            </a:r>
            <a:r>
              <a:rPr lang="en-US" altLang="ja-JP" sz="10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15</a:t>
            </a:r>
            <a:endParaRPr kumimoji="1" lang="ja-JP" altLang="en-US" sz="1000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  <p:cxnSp>
        <p:nvCxnSpPr>
          <p:cNvPr id="66" name="直線コネクタ 65">
            <a:extLst>
              <a:ext uri="{FF2B5EF4-FFF2-40B4-BE49-F238E27FC236}">
                <a16:creationId xmlns:a16="http://schemas.microsoft.com/office/drawing/2014/main" id="{4C4B5FF8-B607-604F-A429-174B5E043D26}"/>
              </a:ext>
            </a:extLst>
          </p:cNvPr>
          <p:cNvCxnSpPr>
            <a:cxnSpLocks/>
          </p:cNvCxnSpPr>
          <p:nvPr/>
        </p:nvCxnSpPr>
        <p:spPr>
          <a:xfrm>
            <a:off x="6582979" y="3221492"/>
            <a:ext cx="3184797" cy="0"/>
          </a:xfrm>
          <a:prstGeom prst="line">
            <a:avLst/>
          </a:prstGeom>
          <a:ln w="15875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76AA6F29-E83D-8941-8A11-04FD3C97BA7A}"/>
              </a:ext>
            </a:extLst>
          </p:cNvPr>
          <p:cNvSpPr txBox="1"/>
          <p:nvPr/>
        </p:nvSpPr>
        <p:spPr>
          <a:xfrm>
            <a:off x="7652159" y="3196155"/>
            <a:ext cx="689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T</a:t>
            </a:r>
            <a:r>
              <a:rPr kumimoji="1" lang="en-US" altLang="ja-JP" sz="1200" b="1" dirty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ypes</a:t>
            </a:r>
            <a:endParaRPr kumimoji="1" lang="ja-JP" altLang="en-US" sz="1200" b="1">
              <a:latin typeface="Verdana" panose="020B0604030504040204" pitchFamily="34" charset="0"/>
              <a:cs typeface="Verdana" panose="020B060403050404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33675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629</TotalTime>
  <Words>223</Words>
  <Application>Microsoft Macintosh PowerPoint</Application>
  <PresentationFormat>ワイド画面</PresentationFormat>
  <Paragraphs>73</Paragraphs>
  <Slides>7</Slides>
  <Notes>3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7</vt:i4>
      </vt:variant>
    </vt:vector>
  </HeadingPairs>
  <TitlesOfParts>
    <vt:vector size="12" baseType="lpstr">
      <vt:lpstr>游ゴシック</vt:lpstr>
      <vt:lpstr>游ゴシック Light</vt:lpstr>
      <vt:lpstr>Arial</vt:lpstr>
      <vt:lpstr>Verdana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omohisa Takagi</dc:creator>
  <cp:lastModifiedBy>Tomohisa Takagi</cp:lastModifiedBy>
  <cp:revision>46</cp:revision>
  <cp:lastPrinted>2021-12-16T10:54:06Z</cp:lastPrinted>
  <dcterms:created xsi:type="dcterms:W3CDTF">2021-08-19T01:47:34Z</dcterms:created>
  <dcterms:modified xsi:type="dcterms:W3CDTF">2021-12-31T06:40:59Z</dcterms:modified>
</cp:coreProperties>
</file>